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77" r:id="rId2"/>
    <p:sldId id="283" r:id="rId3"/>
    <p:sldId id="292" r:id="rId4"/>
    <p:sldId id="286" r:id="rId5"/>
    <p:sldId id="280" r:id="rId6"/>
    <p:sldId id="294" r:id="rId7"/>
    <p:sldId id="295" r:id="rId8"/>
    <p:sldId id="296" r:id="rId9"/>
    <p:sldId id="297" r:id="rId10"/>
    <p:sldId id="298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1D9ED"/>
    <a:srgbClr val="FFFFFF"/>
    <a:srgbClr val="E7F1FA"/>
    <a:srgbClr val="87CEEA"/>
    <a:srgbClr val="A6D396"/>
    <a:srgbClr val="F4B898"/>
    <a:srgbClr val="AEAEAE"/>
    <a:srgbClr val="CF95C9"/>
    <a:srgbClr val="F7FBFF"/>
    <a:srgbClr val="E9F2F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7668" autoAdjust="0"/>
    <p:restoredTop sz="93969" autoAdjust="0"/>
  </p:normalViewPr>
  <p:slideViewPr>
    <p:cSldViewPr snapToGrid="0">
      <p:cViewPr varScale="1">
        <p:scale>
          <a:sx n="111" d="100"/>
          <a:sy n="111" d="100"/>
        </p:scale>
        <p:origin x="101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5B688D-DE4E-4013-876F-6A0BEEE91E07}" type="datetimeFigureOut">
              <a:rPr lang="en-US" smtClean="0"/>
              <a:t>10/3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8DD77BF-42AF-4CFA-A70B-E667ABD74E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17190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E0D7A4-4358-9CDE-D4D1-FC15CA385F4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8BF8DE6-8445-92F3-A4D3-A3198098AF1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32A4DA-388F-4438-EB39-C6310946B1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49FDB-6C80-4A34-885C-492A7BAE5B10}" type="datetimeFigureOut">
              <a:rPr lang="en-US" smtClean="0"/>
              <a:t>10/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123177-A7A6-C3F8-9843-10C3CEDD18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556239-50C7-1AF4-DA78-C154B792E2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77C73-D988-469B-B03F-6C862A0078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55580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22F93D-DCEE-A175-BD14-8FB3CEBD77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64C5AED-3467-7B84-AD49-BFF3C385D0C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1472FA-5076-11F3-F637-5517998434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49FDB-6C80-4A34-885C-492A7BAE5B10}" type="datetimeFigureOut">
              <a:rPr lang="en-US" smtClean="0"/>
              <a:t>10/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3FAA2BB-5C42-59C3-0DE1-F8FAE8FEAF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34C4E1-06D3-B01E-CFF7-510029E5D3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77C73-D988-469B-B03F-6C862A0078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79441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02441FF-A67A-CF83-A978-4BD4B6C92C7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803FF6B-6ED7-CA03-52CF-720D227323C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EF60DC-C926-9420-04AF-5B799B74A9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49FDB-6C80-4A34-885C-492A7BAE5B10}" type="datetimeFigureOut">
              <a:rPr lang="en-US" smtClean="0"/>
              <a:t>10/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42DCAA-9CE4-09E3-8B58-B2BA8475F8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011F71-91A6-8763-419D-80887E7C24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77C73-D988-469B-B03F-6C862A0078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91340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BF3644-EA2C-BFE7-EBE3-4CA1BD2749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07AB483-6376-0AF8-36A0-E44C245C7AB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8C6AF2-6B0A-0D81-3666-393F88BD87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49FDB-6C80-4A34-885C-492A7BAE5B10}" type="datetimeFigureOut">
              <a:rPr lang="en-US" smtClean="0"/>
              <a:t>10/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0B47F3-A659-3C06-81C9-17525DD0EE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357AB6-523F-0861-A795-2A0E267430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77C73-D988-469B-B03F-6C862A0078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60724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A0E01B-279B-CA90-1210-AFBCF29E22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7D676A7-CCEE-892C-F597-0A318A42AF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5DF274-56C3-1252-0148-880DDD05FA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49FDB-6C80-4A34-885C-492A7BAE5B10}" type="datetimeFigureOut">
              <a:rPr lang="en-US" smtClean="0"/>
              <a:t>10/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0668B0-7C5F-4018-A6B1-F0D56BE35F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A0DAED-9CCD-7192-DF87-950A0B799E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77C73-D988-469B-B03F-6C862A0078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21682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5866ED-7F81-5E0B-2A2C-52BF27E28A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0F3FDFF-F066-3133-71F1-82410F5908E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09BFFFB-C7DA-29FA-E71C-B7E669162D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3CF879C-9134-EFED-974A-CB0B374912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49FDB-6C80-4A34-885C-492A7BAE5B10}" type="datetimeFigureOut">
              <a:rPr lang="en-US" smtClean="0"/>
              <a:t>10/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48810C1-67BF-95A1-6423-0180A6F2A1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E3BCF1E-F6E4-3A26-7297-54A5C6BE0E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77C73-D988-469B-B03F-6C862A0078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98322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D22D07-CAB9-EC3D-A5BF-6B708B91C1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87CB456-3F6D-1973-5B63-4F60BEF0EA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840EC34-A58C-D6FA-1E14-E932E2A6C1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66132FE-6B9D-B1B3-6E23-7394EE09725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88CCE41-0F4D-421E-3120-7A5BD9B36A0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3C0814A-8F90-7C73-01F4-DDBBFF9102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49FDB-6C80-4A34-885C-492A7BAE5B10}" type="datetimeFigureOut">
              <a:rPr lang="en-US" smtClean="0"/>
              <a:t>10/3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B60CC2D-18EF-08A4-A879-DC0ED088F1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E5F8CCA-1D5C-9FE2-5180-0D7EB1DE55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77C73-D988-469B-B03F-6C862A0078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90927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2AC2DD-F67F-FCD3-6059-4BCE896148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FBB443D-C508-8B39-AF9E-5D4AA77C8F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49FDB-6C80-4A34-885C-492A7BAE5B10}" type="datetimeFigureOut">
              <a:rPr lang="en-US" smtClean="0"/>
              <a:t>10/3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32A1D79-D9F9-ECD2-7877-252B63F235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CDCFCA4-F5D3-1103-6F77-6D46D4395F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77C73-D988-469B-B03F-6C862A0078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64434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5A11043-C34F-5B0D-13CB-C6ED08FD00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49FDB-6C80-4A34-885C-492A7BAE5B10}" type="datetimeFigureOut">
              <a:rPr lang="en-US" smtClean="0"/>
              <a:t>10/3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75630C8-B9FE-7679-3B59-F049793FFF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B09A073-C3C1-6CF8-FA2D-DBF35DC6DD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77C73-D988-469B-B03F-6C862A0078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7178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A1A09E-90EE-1BA1-63E7-2B0A2F8075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F02849D-4206-A367-7823-038E326C5FC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987367A-5A11-FB3B-E70D-710A71D8A7C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7929104-BC7D-F73C-B9CA-8FD14A751E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49FDB-6C80-4A34-885C-492A7BAE5B10}" type="datetimeFigureOut">
              <a:rPr lang="en-US" smtClean="0"/>
              <a:t>10/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AC9DD2D-8181-3C03-F627-269DC081AD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ABBB582-0EA2-7925-FB7B-0AE8CB883B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77C73-D988-469B-B03F-6C862A0078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56149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63F216-27D3-97F1-E5AA-FE28FC382E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03F0A95-820C-5DCA-A77D-023225A3E8E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3CD054E-2754-B72A-A72B-0B7E343989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8626DB5-4B96-E11F-9E12-D4E3C104B5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49FDB-6C80-4A34-885C-492A7BAE5B10}" type="datetimeFigureOut">
              <a:rPr lang="en-US" smtClean="0"/>
              <a:t>10/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ECAC818-AECF-B203-6536-9F789A64C5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C16AEAF-E62B-56F1-5BA9-2FCFD850EE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77C73-D988-469B-B03F-6C862A0078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28872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30494FE-A1FF-DE6F-5621-047A2C4EF2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DE6CFD7-56FF-D550-FA85-E9F4BB2F29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F21655-E610-9865-9F18-A43FAE8000D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4849FDB-6C80-4A34-885C-492A7BAE5B10}" type="datetimeFigureOut">
              <a:rPr lang="en-US" smtClean="0"/>
              <a:t>10/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60B61A-F434-3396-D1BC-27D0795D571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050582-48F6-8989-AD8C-34D60E7A385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A277C73-D988-469B-B03F-6C862A0078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40339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6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6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6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 descr="A graph with blue and white text&#10;&#10;AI-generated content may be incorrect.">
            <a:extLst>
              <a:ext uri="{FF2B5EF4-FFF2-40B4-BE49-F238E27FC236}">
                <a16:creationId xmlns:a16="http://schemas.microsoft.com/office/drawing/2014/main" id="{F59BAC0A-1EB9-F16D-16D1-206619E7BB8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3369365"/>
            <a:ext cx="4934586" cy="3454211"/>
          </a:xfrm>
          <a:prstGeom prst="rect">
            <a:avLst/>
          </a:prstGeom>
        </p:spPr>
      </p:pic>
      <p:pic>
        <p:nvPicPr>
          <p:cNvPr id="7" name="Picture 6" descr="A diagram with text overlay&#10;&#10;AI-generated content may be incorrect.">
            <a:extLst>
              <a:ext uri="{FF2B5EF4-FFF2-40B4-BE49-F238E27FC236}">
                <a16:creationId xmlns:a16="http://schemas.microsoft.com/office/drawing/2014/main" id="{CBBF6871-AB64-BBA6-70EA-0DD14B027B9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0"/>
            <a:ext cx="4934586" cy="3454211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8CB63A39-D0EB-A1F8-249D-940A85802944}"/>
              </a:ext>
            </a:extLst>
          </p:cNvPr>
          <p:cNvSpPr txBox="1"/>
          <p:nvPr/>
        </p:nvSpPr>
        <p:spPr>
          <a:xfrm>
            <a:off x="0" y="0"/>
            <a:ext cx="603948" cy="400110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E430CC9-7E14-8576-1B60-C5638C1C1E15}"/>
              </a:ext>
            </a:extLst>
          </p:cNvPr>
          <p:cNvSpPr txBox="1"/>
          <p:nvPr/>
        </p:nvSpPr>
        <p:spPr>
          <a:xfrm>
            <a:off x="5871579" y="0"/>
            <a:ext cx="603948" cy="400110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E1BDCDA-7A5E-CED5-B312-D85A9130B941}"/>
              </a:ext>
            </a:extLst>
          </p:cNvPr>
          <p:cNvSpPr txBox="1"/>
          <p:nvPr/>
        </p:nvSpPr>
        <p:spPr>
          <a:xfrm>
            <a:off x="-1" y="3369365"/>
            <a:ext cx="603948" cy="400110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</a:p>
        </p:txBody>
      </p:sp>
      <p:pic>
        <p:nvPicPr>
          <p:cNvPr id="4" name="Picture 3" descr="A screen shot of a chart&#10;&#10;AI-generated content may be incorrect.">
            <a:extLst>
              <a:ext uri="{FF2B5EF4-FFF2-40B4-BE49-F238E27FC236}">
                <a16:creationId xmlns:a16="http://schemas.microsoft.com/office/drawing/2014/main" id="{A59A231C-01A2-0A04-9A95-4847BCAB275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16842" y="0"/>
            <a:ext cx="5775158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5707078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900FF42-12B2-1904-9699-0B0A5361B8D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CA2E0B-1A71-9018-C5BE-5376B7F4D5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0"/>
            <a:ext cx="10515600" cy="255977"/>
          </a:xfrm>
        </p:spPr>
        <p:txBody>
          <a:bodyPr>
            <a:no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SSO STK PDPs    </a:t>
            </a:r>
          </a:p>
        </p:txBody>
      </p:sp>
      <p:pic>
        <p:nvPicPr>
          <p:cNvPr id="11" name="Picture 10" descr="A graph of a graph&#10;&#10;AI-generated content may be incorrect.">
            <a:extLst>
              <a:ext uri="{FF2B5EF4-FFF2-40B4-BE49-F238E27FC236}">
                <a16:creationId xmlns:a16="http://schemas.microsoft.com/office/drawing/2014/main" id="{75B8D246-FA01-BA52-A8F9-4120688B909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7080" y="222514"/>
            <a:ext cx="5237839" cy="66354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938977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6D12F08-0EED-C174-3EE9-C99DD6C74CA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E8FA89B3-287D-D719-C262-459FB8A27E4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5029201" cy="3520441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7C4BAAF9-2969-7738-AF95-D21EA871162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" y="3337559"/>
            <a:ext cx="5029201" cy="352044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51EFBD5D-344E-928C-4A6A-E0DCB9432FB0}"/>
              </a:ext>
            </a:extLst>
          </p:cNvPr>
          <p:cNvSpPr txBox="1"/>
          <p:nvPr/>
        </p:nvSpPr>
        <p:spPr>
          <a:xfrm>
            <a:off x="0" y="0"/>
            <a:ext cx="603948" cy="400110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7B1E62B-E033-9651-A095-729D12770ED3}"/>
              </a:ext>
            </a:extLst>
          </p:cNvPr>
          <p:cNvSpPr txBox="1"/>
          <p:nvPr/>
        </p:nvSpPr>
        <p:spPr>
          <a:xfrm>
            <a:off x="5871579" y="0"/>
            <a:ext cx="603948" cy="400110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D7D698E-4485-0A92-8928-3995D754048C}"/>
              </a:ext>
            </a:extLst>
          </p:cNvPr>
          <p:cNvSpPr txBox="1"/>
          <p:nvPr/>
        </p:nvSpPr>
        <p:spPr>
          <a:xfrm>
            <a:off x="-1" y="3369365"/>
            <a:ext cx="603948" cy="400110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0697BC74-A353-2475-C3DD-2685F35CAB5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16841" y="0"/>
            <a:ext cx="5775158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153512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02BBB39-4EEF-3A8F-A0F4-48531DF209D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graph with blue and white bars&#10;&#10;AI-generated content may be incorrect.">
            <a:extLst>
              <a:ext uri="{FF2B5EF4-FFF2-40B4-BE49-F238E27FC236}">
                <a16:creationId xmlns:a16="http://schemas.microsoft.com/office/drawing/2014/main" id="{14008B74-216E-102C-7A81-5683D6B250F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3429000"/>
            <a:ext cx="4898572" cy="3429001"/>
          </a:xfrm>
          <a:prstGeom prst="rect">
            <a:avLst/>
          </a:prstGeom>
        </p:spPr>
      </p:pic>
      <p:pic>
        <p:nvPicPr>
          <p:cNvPr id="8" name="Picture 7" descr="A graph with a bar and a bar chart&#10;&#10;AI-generated content may be incorrect.">
            <a:extLst>
              <a:ext uri="{FF2B5EF4-FFF2-40B4-BE49-F238E27FC236}">
                <a16:creationId xmlns:a16="http://schemas.microsoft.com/office/drawing/2014/main" id="{719EEF96-02C8-6D6F-FE1E-96EF81EB60F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4898572" cy="3429001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BC7A6F52-CE5F-F6CA-5350-2137D94827F0}"/>
              </a:ext>
            </a:extLst>
          </p:cNvPr>
          <p:cNvSpPr txBox="1"/>
          <p:nvPr/>
        </p:nvSpPr>
        <p:spPr>
          <a:xfrm>
            <a:off x="0" y="0"/>
            <a:ext cx="603948" cy="400110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710F67E-76F4-8B45-E343-F7E13A946C40}"/>
              </a:ext>
            </a:extLst>
          </p:cNvPr>
          <p:cNvSpPr txBox="1"/>
          <p:nvPr/>
        </p:nvSpPr>
        <p:spPr>
          <a:xfrm>
            <a:off x="5871579" y="0"/>
            <a:ext cx="603948" cy="400110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C6915DD-1506-9652-72B0-9E489DB1EE1D}"/>
              </a:ext>
            </a:extLst>
          </p:cNvPr>
          <p:cNvSpPr txBox="1"/>
          <p:nvPr/>
        </p:nvSpPr>
        <p:spPr>
          <a:xfrm>
            <a:off x="-1" y="3369365"/>
            <a:ext cx="603948" cy="400110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</a:p>
        </p:txBody>
      </p:sp>
      <p:pic>
        <p:nvPicPr>
          <p:cNvPr id="10" name="Picture 9" descr="A screen shot of a chart&#10;&#10;AI-generated content may be incorrect.">
            <a:extLst>
              <a:ext uri="{FF2B5EF4-FFF2-40B4-BE49-F238E27FC236}">
                <a16:creationId xmlns:a16="http://schemas.microsoft.com/office/drawing/2014/main" id="{3396F435-0517-A2C8-7A22-FEEB31E77B2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16842" y="0"/>
            <a:ext cx="5775158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12146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F3DE386-5371-49CA-7A28-2808BCE4208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A graph with blue and white bars&#10;&#10;AI-generated content may be incorrect.">
            <a:extLst>
              <a:ext uri="{FF2B5EF4-FFF2-40B4-BE49-F238E27FC236}">
                <a16:creationId xmlns:a16="http://schemas.microsoft.com/office/drawing/2014/main" id="{09F8828E-2DC8-7FFA-69AE-DA77858ABF0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-2"/>
            <a:ext cx="4905830" cy="3434081"/>
          </a:xfrm>
          <a:prstGeom prst="rect">
            <a:avLst/>
          </a:prstGeom>
        </p:spPr>
      </p:pic>
      <p:pic>
        <p:nvPicPr>
          <p:cNvPr id="13" name="Picture 12" descr="A graph of a number of patients&#10;&#10;AI-generated content may be incorrect.">
            <a:extLst>
              <a:ext uri="{FF2B5EF4-FFF2-40B4-BE49-F238E27FC236}">
                <a16:creationId xmlns:a16="http://schemas.microsoft.com/office/drawing/2014/main" id="{03673BF9-F1D3-C942-64E5-71612BA08E2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428999"/>
            <a:ext cx="4905830" cy="3434081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455F81E-B170-B94E-6235-9C7905F1456C}"/>
              </a:ext>
            </a:extLst>
          </p:cNvPr>
          <p:cNvSpPr txBox="1"/>
          <p:nvPr/>
        </p:nvSpPr>
        <p:spPr>
          <a:xfrm>
            <a:off x="0" y="0"/>
            <a:ext cx="603948" cy="400110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56861F6-3597-D8E2-8925-D49421848385}"/>
              </a:ext>
            </a:extLst>
          </p:cNvPr>
          <p:cNvSpPr txBox="1"/>
          <p:nvPr/>
        </p:nvSpPr>
        <p:spPr>
          <a:xfrm>
            <a:off x="5871579" y="0"/>
            <a:ext cx="603948" cy="400110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CE0588D-CFB2-4202-9DC6-C0731A1F1B29}"/>
              </a:ext>
            </a:extLst>
          </p:cNvPr>
          <p:cNvSpPr txBox="1"/>
          <p:nvPr/>
        </p:nvSpPr>
        <p:spPr>
          <a:xfrm>
            <a:off x="-1" y="3369365"/>
            <a:ext cx="603948" cy="400110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</a:p>
        </p:txBody>
      </p:sp>
      <p:pic>
        <p:nvPicPr>
          <p:cNvPr id="11" name="Picture 10" descr="A screen shot of a chart&#10;&#10;AI-generated content may be incorrect.">
            <a:extLst>
              <a:ext uri="{FF2B5EF4-FFF2-40B4-BE49-F238E27FC236}">
                <a16:creationId xmlns:a16="http://schemas.microsoft.com/office/drawing/2014/main" id="{92168613-32F5-80D3-F86A-EC7373D8303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16842" y="-1"/>
            <a:ext cx="5775158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7062039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F9353E3-E18B-5F37-9D8E-2BCD052EE35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A graph with blue and white bars&#10;&#10;AI-generated content may be incorrect.">
            <a:extLst>
              <a:ext uri="{FF2B5EF4-FFF2-40B4-BE49-F238E27FC236}">
                <a16:creationId xmlns:a16="http://schemas.microsoft.com/office/drawing/2014/main" id="{68C55416-6FAB-7B69-04F6-3B1DCE3656F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0"/>
            <a:ext cx="4874916" cy="3412442"/>
          </a:xfrm>
          <a:prstGeom prst="rect">
            <a:avLst/>
          </a:prstGeom>
        </p:spPr>
      </p:pic>
      <p:pic>
        <p:nvPicPr>
          <p:cNvPr id="14" name="Picture 13" descr="A graph with blue and white bars&#10;&#10;AI-generated content may be incorrect.">
            <a:extLst>
              <a:ext uri="{FF2B5EF4-FFF2-40B4-BE49-F238E27FC236}">
                <a16:creationId xmlns:a16="http://schemas.microsoft.com/office/drawing/2014/main" id="{84655699-6506-F585-0FCA-9204062BFDE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445559"/>
            <a:ext cx="4874916" cy="3412442"/>
          </a:xfrm>
          <a:prstGeom prst="rect">
            <a:avLst/>
          </a:prstGeom>
        </p:spPr>
      </p:pic>
      <p:sp>
        <p:nvSpPr>
          <p:cNvPr id="4" name="AutoShape 2">
            <a:extLst>
              <a:ext uri="{FF2B5EF4-FFF2-40B4-BE49-F238E27FC236}">
                <a16:creationId xmlns:a16="http://schemas.microsoft.com/office/drawing/2014/main" id="{73A00C3B-9AA9-15DC-270E-E2085F1E5DBB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5943599" y="1362075"/>
            <a:ext cx="2219325" cy="22193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9D29949-1C90-6BEC-62B4-15CEBAC4DCF6}"/>
              </a:ext>
            </a:extLst>
          </p:cNvPr>
          <p:cNvSpPr txBox="1"/>
          <p:nvPr/>
        </p:nvSpPr>
        <p:spPr>
          <a:xfrm>
            <a:off x="0" y="0"/>
            <a:ext cx="603948" cy="400110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7341E5E-B02F-5CD6-F75E-8606906A3026}"/>
              </a:ext>
            </a:extLst>
          </p:cNvPr>
          <p:cNvSpPr txBox="1"/>
          <p:nvPr/>
        </p:nvSpPr>
        <p:spPr>
          <a:xfrm>
            <a:off x="5871579" y="0"/>
            <a:ext cx="603948" cy="400110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EE60DC5-6785-4B82-C5E3-0C316CE5E42B}"/>
              </a:ext>
            </a:extLst>
          </p:cNvPr>
          <p:cNvSpPr txBox="1"/>
          <p:nvPr/>
        </p:nvSpPr>
        <p:spPr>
          <a:xfrm>
            <a:off x="-1" y="3369365"/>
            <a:ext cx="603948" cy="400110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</a:p>
        </p:txBody>
      </p:sp>
      <p:pic>
        <p:nvPicPr>
          <p:cNvPr id="12" name="Picture 11" descr="A screen shot of a graph&#10;&#10;AI-generated content may be incorrect.">
            <a:extLst>
              <a:ext uri="{FF2B5EF4-FFF2-40B4-BE49-F238E27FC236}">
                <a16:creationId xmlns:a16="http://schemas.microsoft.com/office/drawing/2014/main" id="{BDF45942-D412-3371-0941-6EE261E25A5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16842" y="0"/>
            <a:ext cx="5775158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2612844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F53B39D-7D0C-B19B-771D-8E1B103C55A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2C74ED-6F67-984E-A17D-07D11E7320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0"/>
            <a:ext cx="10515600" cy="255977"/>
          </a:xfrm>
        </p:spPr>
        <p:txBody>
          <a:bodyPr>
            <a:no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nual XGB PDPs    </a:t>
            </a:r>
          </a:p>
        </p:txBody>
      </p:sp>
      <p:pic>
        <p:nvPicPr>
          <p:cNvPr id="15" name="Picture 14" descr="A group of graphs on a white background&#10;&#10;AI-generated content may be incorrect.">
            <a:extLst>
              <a:ext uri="{FF2B5EF4-FFF2-40B4-BE49-F238E27FC236}">
                <a16:creationId xmlns:a16="http://schemas.microsoft.com/office/drawing/2014/main" id="{C56A97DC-E2DA-7C92-C27C-5F481F2C0C0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2223" y="222514"/>
            <a:ext cx="5047554" cy="66354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0429022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2C94FC8-DCC7-188E-CDF8-7FC18D89A47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B45350-E634-80D5-972E-FE5E739343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0"/>
            <a:ext cx="10515600" cy="255977"/>
          </a:xfrm>
        </p:spPr>
        <p:txBody>
          <a:bodyPr>
            <a:noAutofit/>
          </a:bodyPr>
          <a:lstStyle/>
          <a:p>
            <a:pPr algn="ctr"/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rutaSHA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R PDPs    </a:t>
            </a:r>
          </a:p>
        </p:txBody>
      </p:sp>
      <p:pic>
        <p:nvPicPr>
          <p:cNvPr id="3" name="Picture 2" descr="A graph of a graph&#10;&#10;AI-generated content may be incorrect.">
            <a:extLst>
              <a:ext uri="{FF2B5EF4-FFF2-40B4-BE49-F238E27FC236}">
                <a16:creationId xmlns:a16="http://schemas.microsoft.com/office/drawing/2014/main" id="{1E485D57-12BB-70D7-1905-16B4B2F6944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0598" y="222514"/>
            <a:ext cx="4990803" cy="66354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1360548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17E6207-1AC3-534D-854E-C2133FEBED9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C169B6-C340-7BCE-F29F-24D4E9CC17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0"/>
            <a:ext cx="10515600" cy="255977"/>
          </a:xfrm>
        </p:spPr>
        <p:txBody>
          <a:bodyPr>
            <a:no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SSO RF PDPs    </a:t>
            </a:r>
          </a:p>
        </p:txBody>
      </p:sp>
      <p:pic>
        <p:nvPicPr>
          <p:cNvPr id="7" name="Picture 6" descr="A graph of a graph&#10;&#10;AI-generated content may be incorrect.">
            <a:extLst>
              <a:ext uri="{FF2B5EF4-FFF2-40B4-BE49-F238E27FC236}">
                <a16:creationId xmlns:a16="http://schemas.microsoft.com/office/drawing/2014/main" id="{8BAB5D3A-4A9E-1534-4307-B9518134B02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4825" y="222514"/>
            <a:ext cx="5282350" cy="66354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678332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EFE23BF-7D6C-72D4-FB64-912B9B31982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162A2E-93E2-07C5-151F-67007209F1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0"/>
            <a:ext cx="10515600" cy="255977"/>
          </a:xfrm>
        </p:spPr>
        <p:txBody>
          <a:bodyPr>
            <a:no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SSO XGB PDPs    </a:t>
            </a:r>
          </a:p>
        </p:txBody>
      </p:sp>
      <p:pic>
        <p:nvPicPr>
          <p:cNvPr id="9" name="Picture 8" descr="A graph of a graph&#10;&#10;AI-generated content may be incorrect.">
            <a:extLst>
              <a:ext uri="{FF2B5EF4-FFF2-40B4-BE49-F238E27FC236}">
                <a16:creationId xmlns:a16="http://schemas.microsoft.com/office/drawing/2014/main" id="{C6C1020A-9745-38C1-236A-39D5878C204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8749" y="222514"/>
            <a:ext cx="5234501" cy="66354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546829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725</TotalTime>
  <Words>45</Words>
  <Application>Microsoft Office PowerPoint</Application>
  <PresentationFormat>Widescreen</PresentationFormat>
  <Paragraphs>20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5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Manual XGB PDPs    </vt:lpstr>
      <vt:lpstr>BorutaSHAP LR PDPs    </vt:lpstr>
      <vt:lpstr>LASSO RF PDPs    </vt:lpstr>
      <vt:lpstr>LASSO XGB PDPs    </vt:lpstr>
      <vt:lpstr>LASSO STK PDPs   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amuel Coeyman</dc:creator>
  <cp:lastModifiedBy>Samuel Coeyman</cp:lastModifiedBy>
  <cp:revision>174</cp:revision>
  <dcterms:created xsi:type="dcterms:W3CDTF">2024-11-18T15:12:35Z</dcterms:created>
  <dcterms:modified xsi:type="dcterms:W3CDTF">2025-10-03T16:22:15Z</dcterms:modified>
</cp:coreProperties>
</file>